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91" r:id="rId2"/>
    <p:sldId id="292" r:id="rId3"/>
    <p:sldId id="293" r:id="rId4"/>
    <p:sldId id="294" r:id="rId5"/>
    <p:sldId id="295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25" userDrawn="1">
          <p15:clr>
            <a:srgbClr val="A4A3A4"/>
          </p15:clr>
        </p15:guide>
        <p15:guide id="2" pos="195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C31"/>
    <a:srgbClr val="C0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16D9F66E-5EB9-4882-86FB-DCBF35E3C3E4}" styleName="Stile medio 4 - Colore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10A1B5D5-9B99-4C35-A422-299274C87663}" styleName="Stile medio 1 - Colore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8799B23B-EC83-4686-B30A-512413B5E67A}" styleName="Stile chiaro 3 - Color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DA37D80-6434-44D0-A028-1B22A696006F}" styleName="Stile chiaro 3 - Colore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C7853C-536D-4A76-A0AE-DD22124D55A5}" styleName="Stile con tema 1 - Colore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75DCB02-9BB8-47FD-8907-85C794F793BA}" styleName="Stile con tema 1 - Colore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284E427A-3D55-4303-BF80-6455036E1DE7}" styleName="Stile con tema 1 - Colore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68D230F3-CF80-4859-8CE7-A43EE81993B5}" styleName="Stile chiaro 1 - Colore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napToObjects="1" showGuides="1">
      <p:cViewPr varScale="1">
        <p:scale>
          <a:sx n="96" d="100"/>
          <a:sy n="96" d="100"/>
        </p:scale>
        <p:origin x="2064" y="90"/>
      </p:cViewPr>
      <p:guideLst>
        <p:guide orient="horz" pos="1525"/>
        <p:guide pos="195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51E2D-06B3-A14A-BADF-1A9EA4A59415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4694A4-5CF1-944E-A3E9-6890100CEA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328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4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74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09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97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334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8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771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755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40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2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708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FF43A-1C4E-0A4A-9EEB-32F96D2AA640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2594B-EE71-BC46-A0FA-3A9236BA5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48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1">
            <a:extLst>
              <a:ext uri="{FF2B5EF4-FFF2-40B4-BE49-F238E27FC236}">
                <a16:creationId xmlns:a16="http://schemas.microsoft.com/office/drawing/2014/main" id="{BBC84F99-8E95-904D-2602-1A456B0539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5957660"/>
              </p:ext>
            </p:extLst>
          </p:nvPr>
        </p:nvGraphicFramePr>
        <p:xfrm>
          <a:off x="1899821" y="1198486"/>
          <a:ext cx="5442011" cy="3277250"/>
        </p:xfrm>
        <a:graphic>
          <a:graphicData uri="http://schemas.openxmlformats.org/drawingml/2006/table">
            <a:tbl>
              <a:tblPr bandRow="1">
                <a:tableStyleId>{68D230F3-CF80-4859-8CE7-A43EE81993B5}</a:tableStyleId>
              </a:tblPr>
              <a:tblGrid>
                <a:gridCol w="15057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93625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9837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Supplementary Table S1. </a:t>
                      </a:r>
                      <a:r>
                        <a:rPr lang="en-US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Current CAR-T Italian commercial Indications for DLBCL</a:t>
                      </a:r>
                    </a:p>
                  </a:txBody>
                  <a:tcPr marL="7589" marR="7589" marT="7589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589" marR="7589" marT="7589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983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roduct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589" marR="7589" marT="75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Indication</a:t>
                      </a:r>
                    </a:p>
                  </a:txBody>
                  <a:tcPr marL="7589" marR="7589" marT="7589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154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Tisagenlecleucel</a:t>
                      </a:r>
                      <a:endParaRPr lang="en-US" sz="1100" b="0" u="none" strike="noStrike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(Tisa-Cel)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589" marR="7589" marT="7589" marB="0" anchor="b"/>
                </a:tc>
                <a:tc>
                  <a:txBody>
                    <a:bodyPr/>
                    <a:lstStyle/>
                    <a:p>
                      <a:pPr marL="171450" indent="-171450" algn="just" fontAlgn="b">
                        <a:buFont typeface="Arial" panose="020B0604020202020204" pitchFamily="34" charset="0"/>
                        <a:buChar char="•"/>
                      </a:pP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Adults with R/R LBCL after ≥ 2 lines of systemic therapy, including DLBCL NOS, high-grade B-cell lymphoma, and DLBCL arising from FL (AIFA approvement in August 2019)</a:t>
                      </a:r>
                    </a:p>
                  </a:txBody>
                  <a:tcPr marL="7589" marR="7589" marT="7589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203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Axicabtageneciloleucel</a:t>
                      </a:r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(Axi-Cel)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589" marR="7589" marT="7589" marB="0" anchor="ctr"/>
                </a:tc>
                <a:tc>
                  <a:txBody>
                    <a:bodyPr/>
                    <a:lstStyle/>
                    <a:p>
                      <a:pPr marL="171450" indent="-171450" algn="just" fontAlgn="b">
                        <a:buFont typeface="Arial" panose="020B0604020202020204" pitchFamily="34" charset="0"/>
                        <a:buChar char="•"/>
                      </a:pP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Adults with LBCL either refractory to first-line chemoimmunotherapy or relapsed within 12 </a:t>
                      </a:r>
                      <a:r>
                        <a:rPr lang="en-US" sz="11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mo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 of first-line chemoimmunotherapy (AIFA approvement in November 2019)</a:t>
                      </a:r>
                    </a:p>
                    <a:p>
                      <a:pPr marL="171450" indent="-171450" algn="just" fontAlgn="b">
                        <a:buFont typeface="Arial" panose="020B0604020202020204" pitchFamily="34" charset="0"/>
                        <a:buChar char="•"/>
                      </a:pP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Adults with R/R LBCL after ≥ 2 lines of systemic therapy, including DLBCL NOS, DLBCL arising from FL, primary mediastinal LBCL, high- grade B-cell lymphoma (AIFA approvement in November 2023) </a:t>
                      </a:r>
                      <a:endParaRPr lang="uk-UA" sz="1100" b="0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589" marR="7589" marT="7589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8520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Lisocabtagenemaraleucel</a:t>
                      </a:r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 (Lisa-Cel)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589" marR="7589" marT="7589" marB="0" anchor="ctr"/>
                </a:tc>
                <a:tc>
                  <a:txBody>
                    <a:bodyPr/>
                    <a:lstStyle/>
                    <a:p>
                      <a:pPr marL="171450" indent="-171450" algn="just" fontAlgn="b">
                        <a:buFont typeface="Arial" panose="020B0604020202020204" pitchFamily="34" charset="0"/>
                        <a:buChar char="•"/>
                      </a:pP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Adults with LBCL, including DLBCL NOS, DLBCL arising from indolent lymphoma, high-grade B-cell lymphoma, primary mediastinal LBCL, and FL grade 3B, who have disease that is R/R after ≥ 2 lines of systemic therapy (AIFA approvement in February 2024)</a:t>
                      </a:r>
                    </a:p>
                    <a:p>
                      <a:pPr marL="0" indent="0" algn="just" fontAlgn="b">
                        <a:buFont typeface="Arial" panose="020B0604020202020204" pitchFamily="34" charset="0"/>
                        <a:buNone/>
                      </a:pP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589" marR="7589" marT="7589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764418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FA55C37E-A47E-C485-3BCB-452FAD9EAB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9637102"/>
              </p:ext>
            </p:extLst>
          </p:nvPr>
        </p:nvGraphicFramePr>
        <p:xfrm>
          <a:off x="2472431" y="1189607"/>
          <a:ext cx="4199137" cy="2334832"/>
        </p:xfrm>
        <a:graphic>
          <a:graphicData uri="http://schemas.openxmlformats.org/drawingml/2006/table">
            <a:tbl>
              <a:tblPr firstRow="1" bandRow="1">
                <a:tableStyleId>{68D230F3-CF80-4859-8CE7-A43EE81993B5}</a:tableStyleId>
              </a:tblPr>
              <a:tblGrid>
                <a:gridCol w="1889155">
                  <a:extLst>
                    <a:ext uri="{9D8B030D-6E8A-4147-A177-3AD203B41FA5}">
                      <a16:colId xmlns:a16="http://schemas.microsoft.com/office/drawing/2014/main" val="4284027966"/>
                    </a:ext>
                  </a:extLst>
                </a:gridCol>
                <a:gridCol w="909709">
                  <a:extLst>
                    <a:ext uri="{9D8B030D-6E8A-4147-A177-3AD203B41FA5}">
                      <a16:colId xmlns:a16="http://schemas.microsoft.com/office/drawing/2014/main" val="1569674685"/>
                    </a:ext>
                  </a:extLst>
                </a:gridCol>
                <a:gridCol w="1400273">
                  <a:extLst>
                    <a:ext uri="{9D8B030D-6E8A-4147-A177-3AD203B41FA5}">
                      <a16:colId xmlns:a16="http://schemas.microsoft.com/office/drawing/2014/main" val="2498361171"/>
                    </a:ext>
                  </a:extLst>
                </a:gridCol>
              </a:tblGrid>
              <a:tr h="291854">
                <a:tc gridSpan="3">
                  <a:txBody>
                    <a:bodyPr/>
                    <a:lstStyle/>
                    <a:p>
                      <a:pPr algn="l" rtl="0" fontAlgn="b"/>
                      <a:r>
                        <a:rPr lang="it-IT" sz="12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Supplementary Table S2</a:t>
                      </a:r>
                      <a:r>
                        <a:rPr lang="it-IT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it-IT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ultivariable</a:t>
                      </a:r>
                      <a:r>
                        <a:rPr lang="it-IT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it-IT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nalysis</a:t>
                      </a:r>
                      <a:r>
                        <a:rPr lang="it-IT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for OS</a:t>
                      </a:r>
                    </a:p>
                  </a:txBody>
                  <a:tcPr marL="4319" marR="4319" marT="4319" marB="0" anchor="b"/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it-IT" sz="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it-IT" sz="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957760979"/>
                  </a:ext>
                </a:extLst>
              </a:tr>
              <a:tr h="291854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ariables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-</a:t>
                      </a:r>
                      <a:r>
                        <a:rPr lang="it-IT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value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>
                          <a:solidFill>
                            <a:schemeClr val="tx1"/>
                          </a:solidFill>
                          <a:effectLst/>
                        </a:rPr>
                        <a:t>HR</a:t>
                      </a:r>
                      <a:endParaRPr lang="it-IT" sz="12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083003003"/>
                  </a:ext>
                </a:extLst>
              </a:tr>
              <a:tr h="291854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414645004"/>
                  </a:ext>
                </a:extLst>
              </a:tr>
              <a:tr h="291854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Tumor</a:t>
                      </a:r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bulk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956</a:t>
                      </a:r>
                      <a:endParaRPr lang="it-IT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0.92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856289236"/>
                  </a:ext>
                </a:extLst>
              </a:tr>
              <a:tr h="291854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&gt;1 </a:t>
                      </a:r>
                      <a:r>
                        <a:rPr lang="it-IT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Extranodal</a:t>
                      </a:r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it-IT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sites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543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914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007428621"/>
                  </a:ext>
                </a:extLst>
              </a:tr>
              <a:tr h="291854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ORR30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97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27</a:t>
                      </a: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789515622"/>
                  </a:ext>
                </a:extLst>
              </a:tr>
              <a:tr h="291854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R90</a:t>
                      </a: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95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78</a:t>
                      </a: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178889776"/>
                  </a:ext>
                </a:extLst>
              </a:tr>
              <a:tr h="291854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idging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therapy</a:t>
                      </a: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0.997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2.744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24641364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042182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476934C6-30E2-BC48-BA9F-933512AADF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9626772"/>
              </p:ext>
            </p:extLst>
          </p:nvPr>
        </p:nvGraphicFramePr>
        <p:xfrm>
          <a:off x="1913062" y="932156"/>
          <a:ext cx="5490915" cy="3378469"/>
        </p:xfrm>
        <a:graphic>
          <a:graphicData uri="http://schemas.openxmlformats.org/drawingml/2006/table">
            <a:tbl>
              <a:tblPr firstRow="1" firstCol="1" lastCol="1" bandRow="1">
                <a:tableStyleId>{68D230F3-CF80-4859-8CE7-A43EE81993B5}</a:tableStyleId>
              </a:tblPr>
              <a:tblGrid>
                <a:gridCol w="1484930">
                  <a:extLst>
                    <a:ext uri="{9D8B030D-6E8A-4147-A177-3AD203B41FA5}">
                      <a16:colId xmlns:a16="http://schemas.microsoft.com/office/drawing/2014/main" val="4284027966"/>
                    </a:ext>
                  </a:extLst>
                </a:gridCol>
                <a:gridCol w="710644">
                  <a:extLst>
                    <a:ext uri="{9D8B030D-6E8A-4147-A177-3AD203B41FA5}">
                      <a16:colId xmlns:a16="http://schemas.microsoft.com/office/drawing/2014/main" val="1569674685"/>
                    </a:ext>
                  </a:extLst>
                </a:gridCol>
                <a:gridCol w="1098447">
                  <a:extLst>
                    <a:ext uri="{9D8B030D-6E8A-4147-A177-3AD203B41FA5}">
                      <a16:colId xmlns:a16="http://schemas.microsoft.com/office/drawing/2014/main" val="2498361171"/>
                    </a:ext>
                  </a:extLst>
                </a:gridCol>
                <a:gridCol w="1098447">
                  <a:extLst>
                    <a:ext uri="{9D8B030D-6E8A-4147-A177-3AD203B41FA5}">
                      <a16:colId xmlns:a16="http://schemas.microsoft.com/office/drawing/2014/main" val="2234203051"/>
                    </a:ext>
                  </a:extLst>
                </a:gridCol>
                <a:gridCol w="1098447">
                  <a:extLst>
                    <a:ext uri="{9D8B030D-6E8A-4147-A177-3AD203B41FA5}">
                      <a16:colId xmlns:a16="http://schemas.microsoft.com/office/drawing/2014/main" val="3456647395"/>
                    </a:ext>
                  </a:extLst>
                </a:gridCol>
              </a:tblGrid>
              <a:tr h="335541">
                <a:tc gridSpan="5">
                  <a:txBody>
                    <a:bodyPr/>
                    <a:lstStyle/>
                    <a:p>
                      <a:pPr algn="just" rtl="0" fontAlgn="b"/>
                      <a:r>
                        <a:rPr lang="it-IT" sz="12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Supplementary Table S3. </a:t>
                      </a:r>
                      <a:r>
                        <a:rPr lang="it-IT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Univariable</a:t>
                      </a:r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it-IT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analysis</a:t>
                      </a:r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for CRS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it-IT" sz="800" b="0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it-IT" sz="800" b="0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it-IT" sz="800" b="0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8133363"/>
                  </a:ext>
                </a:extLst>
              </a:tr>
              <a:tr h="335541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Variables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-</a:t>
                      </a:r>
                      <a:r>
                        <a:rPr lang="it-IT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value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HR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95% CI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3003003"/>
                  </a:ext>
                </a:extLst>
              </a:tr>
              <a:tr h="335541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ower</a:t>
                      </a:r>
                      <a:endParaRPr lang="it-IT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Upper</a:t>
                      </a:r>
                      <a:endParaRPr lang="it-IT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414645004"/>
                  </a:ext>
                </a:extLst>
              </a:tr>
              <a:tr h="335541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Age</a:t>
                      </a:r>
                      <a:endParaRPr lang="it-IT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83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90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62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017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3031137569"/>
                  </a:ext>
                </a:extLst>
              </a:tr>
              <a:tr h="335541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Tumor</a:t>
                      </a:r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bulk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12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3.386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1.31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.746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856289236"/>
                  </a:ext>
                </a:extLst>
              </a:tr>
              <a:tr h="335541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&gt;1 </a:t>
                      </a:r>
                      <a:r>
                        <a:rPr lang="it-IT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Extranodal</a:t>
                      </a:r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it-IT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sites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112</a:t>
                      </a:r>
                      <a:endParaRPr lang="it-IT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.362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02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908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007428621"/>
                  </a:ext>
                </a:extLst>
              </a:tr>
              <a:tr h="335541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ECOG&gt;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784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16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19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.492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178889776"/>
                  </a:ext>
                </a:extLst>
              </a:tr>
              <a:tr h="335541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Baseline high CRP </a:t>
                      </a:r>
                    </a:p>
                    <a:p>
                      <a:pPr algn="l" rtl="0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&gt;3 mg/dl)</a:t>
                      </a: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731</a:t>
                      </a:r>
                      <a:endParaRPr lang="it-IT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08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240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.720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3393714137"/>
                  </a:ext>
                </a:extLst>
              </a:tr>
              <a:tr h="659603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Baseline high Ferritine</a:t>
                      </a:r>
                    </a:p>
                    <a:p>
                      <a:pPr algn="l" rtl="0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&gt;650 ng/ml)</a:t>
                      </a:r>
                    </a:p>
                  </a:txBody>
                  <a:tcPr marL="4319" marR="4319" marT="431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586</a:t>
                      </a:r>
                      <a:endParaRPr lang="it-IT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790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38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846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ctr"/>
                </a:tc>
                <a:extLst>
                  <a:ext uri="{0D108BD9-81ED-4DB2-BD59-A6C34878D82A}">
                    <a16:rowId xmlns:a16="http://schemas.microsoft.com/office/drawing/2014/main" val="12585341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468238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189C6CFE-800B-3B30-7F13-89D9CFCEB2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1325531"/>
              </p:ext>
            </p:extLst>
          </p:nvPr>
        </p:nvGraphicFramePr>
        <p:xfrm>
          <a:off x="2176786" y="816746"/>
          <a:ext cx="4891595" cy="2998536"/>
        </p:xfrm>
        <a:graphic>
          <a:graphicData uri="http://schemas.openxmlformats.org/drawingml/2006/table">
            <a:tbl>
              <a:tblPr firstRow="1" bandRow="1">
                <a:tableStyleId>{68D230F3-CF80-4859-8CE7-A43EE81993B5}</a:tableStyleId>
              </a:tblPr>
              <a:tblGrid>
                <a:gridCol w="1322854">
                  <a:extLst>
                    <a:ext uri="{9D8B030D-6E8A-4147-A177-3AD203B41FA5}">
                      <a16:colId xmlns:a16="http://schemas.microsoft.com/office/drawing/2014/main" val="4284027966"/>
                    </a:ext>
                  </a:extLst>
                </a:gridCol>
                <a:gridCol w="633079">
                  <a:extLst>
                    <a:ext uri="{9D8B030D-6E8A-4147-A177-3AD203B41FA5}">
                      <a16:colId xmlns:a16="http://schemas.microsoft.com/office/drawing/2014/main" val="1569674685"/>
                    </a:ext>
                  </a:extLst>
                </a:gridCol>
                <a:gridCol w="978554">
                  <a:extLst>
                    <a:ext uri="{9D8B030D-6E8A-4147-A177-3AD203B41FA5}">
                      <a16:colId xmlns:a16="http://schemas.microsoft.com/office/drawing/2014/main" val="2498361171"/>
                    </a:ext>
                  </a:extLst>
                </a:gridCol>
                <a:gridCol w="978554">
                  <a:extLst>
                    <a:ext uri="{9D8B030D-6E8A-4147-A177-3AD203B41FA5}">
                      <a16:colId xmlns:a16="http://schemas.microsoft.com/office/drawing/2014/main" val="2234203051"/>
                    </a:ext>
                  </a:extLst>
                </a:gridCol>
                <a:gridCol w="978554">
                  <a:extLst>
                    <a:ext uri="{9D8B030D-6E8A-4147-A177-3AD203B41FA5}">
                      <a16:colId xmlns:a16="http://schemas.microsoft.com/office/drawing/2014/main" val="3456647395"/>
                    </a:ext>
                  </a:extLst>
                </a:gridCol>
              </a:tblGrid>
              <a:tr h="275105">
                <a:tc gridSpan="5">
                  <a:txBody>
                    <a:bodyPr/>
                    <a:lstStyle/>
                    <a:p>
                      <a:pPr algn="just" rtl="0" fontAlgn="b"/>
                      <a:r>
                        <a:rPr lang="it-IT" sz="12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Supplementary Table S4. </a:t>
                      </a:r>
                      <a:r>
                        <a:rPr lang="it-IT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Univariable</a:t>
                      </a:r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it-IT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analysis</a:t>
                      </a:r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for ICANS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it-IT" sz="800" b="0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it-IT" sz="800" b="0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it-IT" sz="800" b="0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4121293"/>
                  </a:ext>
                </a:extLst>
              </a:tr>
              <a:tr h="275105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Variables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-</a:t>
                      </a:r>
                      <a:r>
                        <a:rPr lang="it-IT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value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HR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95% CI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3003003"/>
                  </a:ext>
                </a:extLst>
              </a:tr>
              <a:tr h="275105"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ower</a:t>
                      </a:r>
                      <a:endParaRPr lang="it-IT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Upper</a:t>
                      </a:r>
                      <a:endParaRPr lang="it-IT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414645004"/>
                  </a:ext>
                </a:extLst>
              </a:tr>
              <a:tr h="275105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Age</a:t>
                      </a:r>
                      <a:endParaRPr lang="it-IT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179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059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74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15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3031137569"/>
                  </a:ext>
                </a:extLst>
              </a:tr>
              <a:tr h="275105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Tumor</a:t>
                      </a:r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bulk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5</a:t>
                      </a:r>
                      <a:endParaRPr lang="it-IT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4.484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 0.790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1.116 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856289236"/>
                  </a:ext>
                </a:extLst>
              </a:tr>
              <a:tr h="424868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&gt;1 </a:t>
                      </a:r>
                      <a:r>
                        <a:rPr lang="it-IT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Extranodal</a:t>
                      </a:r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it-IT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sites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93</a:t>
                      </a:r>
                      <a:endParaRPr lang="it-IT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.083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802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908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007428621"/>
                  </a:ext>
                </a:extLst>
              </a:tr>
              <a:tr h="275105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ECOG&gt;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547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44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/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178889776"/>
                  </a:ext>
                </a:extLst>
              </a:tr>
              <a:tr h="275105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Baseline high CRP (&gt;3 mg/dl) 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077</a:t>
                      </a:r>
                      <a:endParaRPr lang="it-IT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285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7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14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3393714137"/>
                  </a:ext>
                </a:extLst>
              </a:tr>
              <a:tr h="540799">
                <a:tc>
                  <a:txBody>
                    <a:bodyPr/>
                    <a:lstStyle/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Baseline high Ferritine </a:t>
                      </a:r>
                    </a:p>
                    <a:p>
                      <a:pPr algn="l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(&gt;650 mg/ml)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0.270</a:t>
                      </a:r>
                      <a:endParaRPr lang="it-IT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10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38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.49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9" marR="4319" marT="4319" marB="0" anchor="b"/>
                </a:tc>
                <a:extLst>
                  <a:ext uri="{0D108BD9-81ED-4DB2-BD59-A6C34878D82A}">
                    <a16:rowId xmlns:a16="http://schemas.microsoft.com/office/drawing/2014/main" val="12585341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651739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 descr="A screenshot of a graph&#10;&#10;AI-generated content may be incorrect.">
            <a:extLst>
              <a:ext uri="{FF2B5EF4-FFF2-40B4-BE49-F238E27FC236}">
                <a16:creationId xmlns:a16="http://schemas.microsoft.com/office/drawing/2014/main" id="{E1CEA7CE-043A-0D37-DFA6-59D565E320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064"/>
          <a:stretch>
            <a:fillRect/>
          </a:stretch>
        </p:blipFill>
        <p:spPr bwMode="auto">
          <a:xfrm>
            <a:off x="2223566" y="36244"/>
            <a:ext cx="4971891" cy="6232327"/>
          </a:xfrm>
          <a:prstGeom prst="rect">
            <a:avLst/>
          </a:prstGeom>
          <a:noFill/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1FD28C2C-7204-DBD6-7048-9319FF9AA924}"/>
              </a:ext>
            </a:extLst>
          </p:cNvPr>
          <p:cNvSpPr txBox="1"/>
          <p:nvPr/>
        </p:nvSpPr>
        <p:spPr>
          <a:xfrm>
            <a:off x="-1730829" y="6361117"/>
            <a:ext cx="10744200" cy="4606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indent="269875" algn="just">
              <a:lnSpc>
                <a:spcPts val="1400"/>
              </a:lnSpc>
              <a:buNone/>
            </a:pPr>
            <a:r>
              <a:rPr lang="en-US" sz="16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1. OS and PFS by line of treatment:</a:t>
            </a:r>
            <a:r>
              <a:rPr lang="en-US" sz="16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Kaplan-Meier curve for OS and PFS based on line of treatment with CAR-T</a:t>
            </a:r>
            <a:endParaRPr lang="it-IT" sz="1600" dirty="0">
              <a:solidFill>
                <a:srgbClr val="000000"/>
              </a:solidFill>
              <a:effectLst/>
              <a:latin typeface="+mj-l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3467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378</Words>
  <Application>Microsoft Office PowerPoint</Application>
  <PresentationFormat>On-screen Show (4:3)</PresentationFormat>
  <Paragraphs>11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e</dc:creator>
  <cp:lastModifiedBy>MDPI</cp:lastModifiedBy>
  <cp:revision>137</cp:revision>
  <dcterms:created xsi:type="dcterms:W3CDTF">2024-10-12T13:22:48Z</dcterms:created>
  <dcterms:modified xsi:type="dcterms:W3CDTF">2025-08-22T06:00:48Z</dcterms:modified>
</cp:coreProperties>
</file>